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0C644C2-4506-45EF-AAA2-DC79BFB7F370}" v="16" dt="2025-06-12T04:22:12.730"/>
    <p1510:client id="{DD047093-C355-48AC-A654-0BB6ED3A7D1C}" v="3" dt="2025-06-12T17:51:31.9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4" d="100"/>
          <a:sy n="44" d="100"/>
        </p:scale>
        <p:origin x="223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udel, Dinesh Babu" userId="2908ddf8-1663-409c-ab74-3501e19b2be6" providerId="ADAL" clId="{A0C644C2-4506-45EF-AAA2-DC79BFB7F370}"/>
    <pc:docChg chg="undo custSel addSld modSld">
      <pc:chgData name="Paudel, Dinesh Babu" userId="2908ddf8-1663-409c-ab74-3501e19b2be6" providerId="ADAL" clId="{A0C644C2-4506-45EF-AAA2-DC79BFB7F370}" dt="2025-06-12T04:22:23.982" v="853" actId="113"/>
      <pc:docMkLst>
        <pc:docMk/>
      </pc:docMkLst>
      <pc:sldChg chg="addSp delSp modSp new mod">
        <pc:chgData name="Paudel, Dinesh Babu" userId="2908ddf8-1663-409c-ab74-3501e19b2be6" providerId="ADAL" clId="{A0C644C2-4506-45EF-AAA2-DC79BFB7F370}" dt="2025-06-12T04:06:04.303" v="842"/>
        <pc:sldMkLst>
          <pc:docMk/>
          <pc:sldMk cId="2833429150" sldId="256"/>
        </pc:sldMkLst>
        <pc:spChg chg="del">
          <ac:chgData name="Paudel, Dinesh Babu" userId="2908ddf8-1663-409c-ab74-3501e19b2be6" providerId="ADAL" clId="{A0C644C2-4506-45EF-AAA2-DC79BFB7F370}" dt="2025-06-12T03:08:53.003" v="1" actId="478"/>
          <ac:spMkLst>
            <pc:docMk/>
            <pc:sldMk cId="2833429150" sldId="256"/>
            <ac:spMk id="2" creationId="{1E1DB046-9CB1-A6C1-D8E5-944DC4E3CDBB}"/>
          </ac:spMkLst>
        </pc:spChg>
        <pc:spChg chg="del">
          <ac:chgData name="Paudel, Dinesh Babu" userId="2908ddf8-1663-409c-ab74-3501e19b2be6" providerId="ADAL" clId="{A0C644C2-4506-45EF-AAA2-DC79BFB7F370}" dt="2025-06-12T03:08:53.003" v="1" actId="478"/>
          <ac:spMkLst>
            <pc:docMk/>
            <pc:sldMk cId="2833429150" sldId="256"/>
            <ac:spMk id="3" creationId="{C02586BF-0358-C4AA-EE9A-C93C21143688}"/>
          </ac:spMkLst>
        </pc:spChg>
        <pc:spChg chg="add mod">
          <ac:chgData name="Paudel, Dinesh Babu" userId="2908ddf8-1663-409c-ab74-3501e19b2be6" providerId="ADAL" clId="{A0C644C2-4506-45EF-AAA2-DC79BFB7F370}" dt="2025-06-12T04:06:04.303" v="842"/>
          <ac:spMkLst>
            <pc:docMk/>
            <pc:sldMk cId="2833429150" sldId="256"/>
            <ac:spMk id="6" creationId="{9531691A-0960-FEE2-BD84-461A0BE0CA81}"/>
          </ac:spMkLst>
        </pc:spChg>
        <pc:picChg chg="add mod modCrop">
          <ac:chgData name="Paudel, Dinesh Babu" userId="2908ddf8-1663-409c-ab74-3501e19b2be6" providerId="ADAL" clId="{A0C644C2-4506-45EF-AAA2-DC79BFB7F370}" dt="2025-06-12T03:09:53.843" v="9" actId="1076"/>
          <ac:picMkLst>
            <pc:docMk/>
            <pc:sldMk cId="2833429150" sldId="256"/>
            <ac:picMk id="5" creationId="{D8D19422-AA05-F358-2F05-EBF62D43D2B4}"/>
          </ac:picMkLst>
        </pc:picChg>
      </pc:sldChg>
      <pc:sldChg chg="addSp delSp modSp add mod">
        <pc:chgData name="Paudel, Dinesh Babu" userId="2908ddf8-1663-409c-ab74-3501e19b2be6" providerId="ADAL" clId="{A0C644C2-4506-45EF-AAA2-DC79BFB7F370}" dt="2025-06-12T04:22:23.982" v="853" actId="113"/>
        <pc:sldMkLst>
          <pc:docMk/>
          <pc:sldMk cId="2460883530" sldId="257"/>
        </pc:sldMkLst>
        <pc:spChg chg="mod">
          <ac:chgData name="Paudel, Dinesh Babu" userId="2908ddf8-1663-409c-ab74-3501e19b2be6" providerId="ADAL" clId="{A0C644C2-4506-45EF-AAA2-DC79BFB7F370}" dt="2025-06-12T04:22:23.982" v="853" actId="113"/>
          <ac:spMkLst>
            <pc:docMk/>
            <pc:sldMk cId="2460883530" sldId="257"/>
            <ac:spMk id="6" creationId="{AFE58A6B-7FB6-98D9-9717-84877A5E54B6}"/>
          </ac:spMkLst>
        </pc:spChg>
        <pc:picChg chg="add mod modCrop">
          <ac:chgData name="Paudel, Dinesh Babu" userId="2908ddf8-1663-409c-ab74-3501e19b2be6" providerId="ADAL" clId="{A0C644C2-4506-45EF-AAA2-DC79BFB7F370}" dt="2025-06-12T04:21:51.490" v="850" actId="1076"/>
          <ac:picMkLst>
            <pc:docMk/>
            <pc:sldMk cId="2460883530" sldId="257"/>
            <ac:picMk id="3" creationId="{E9BB883B-F103-0BFD-7F58-B9F6361216B7}"/>
          </ac:picMkLst>
        </pc:picChg>
        <pc:picChg chg="del">
          <ac:chgData name="Paudel, Dinesh Babu" userId="2908ddf8-1663-409c-ab74-3501e19b2be6" providerId="ADAL" clId="{A0C644C2-4506-45EF-AAA2-DC79BFB7F370}" dt="2025-06-12T04:21:32.265" v="844" actId="478"/>
          <ac:picMkLst>
            <pc:docMk/>
            <pc:sldMk cId="2460883530" sldId="257"/>
            <ac:picMk id="5" creationId="{B3ACF9EB-F6B3-94D0-665E-205C79AD1558}"/>
          </ac:picMkLst>
        </pc:picChg>
      </pc:sldChg>
    </pc:docChg>
  </pc:docChgLst>
  <pc:docChgLst>
    <pc:chgData name="Sanfacon, Helene (AAFC/AAC)" userId="72064665-392b-46b2-86df-11307443f336" providerId="ADAL" clId="{DD047093-C355-48AC-A654-0BB6ED3A7D1C}"/>
    <pc:docChg chg="delSld modSld">
      <pc:chgData name="Sanfacon, Helene (AAFC/AAC)" userId="72064665-392b-46b2-86df-11307443f336" providerId="ADAL" clId="{DD047093-C355-48AC-A654-0BB6ED3A7D1C}" dt="2025-06-12T19:13:50.204" v="252" actId="20577"/>
      <pc:docMkLst>
        <pc:docMk/>
      </pc:docMkLst>
      <pc:sldChg chg="addSp modSp mod">
        <pc:chgData name="Sanfacon, Helene (AAFC/AAC)" userId="72064665-392b-46b2-86df-11307443f336" providerId="ADAL" clId="{DD047093-C355-48AC-A654-0BB6ED3A7D1C}" dt="2025-06-12T19:13:50.204" v="252" actId="20577"/>
        <pc:sldMkLst>
          <pc:docMk/>
          <pc:sldMk cId="2833429150" sldId="256"/>
        </pc:sldMkLst>
        <pc:spChg chg="add mod">
          <ac:chgData name="Sanfacon, Helene (AAFC/AAC)" userId="72064665-392b-46b2-86df-11307443f336" providerId="ADAL" clId="{DD047093-C355-48AC-A654-0BB6ED3A7D1C}" dt="2025-06-12T17:50:52.139" v="216" actId="1076"/>
          <ac:spMkLst>
            <pc:docMk/>
            <pc:sldMk cId="2833429150" sldId="256"/>
            <ac:spMk id="2" creationId="{613B8530-C2F5-8AF4-15A4-BCB37896AA41}"/>
          </ac:spMkLst>
        </pc:spChg>
        <pc:spChg chg="add mod">
          <ac:chgData name="Sanfacon, Helene (AAFC/AAC)" userId="72064665-392b-46b2-86df-11307443f336" providerId="ADAL" clId="{DD047093-C355-48AC-A654-0BB6ED3A7D1C}" dt="2025-06-12T17:50:52.139" v="216" actId="1076"/>
          <ac:spMkLst>
            <pc:docMk/>
            <pc:sldMk cId="2833429150" sldId="256"/>
            <ac:spMk id="3" creationId="{F1B4D12C-FAB0-41F3-196B-CB0C6B26B8C3}"/>
          </ac:spMkLst>
        </pc:spChg>
        <pc:spChg chg="add mod">
          <ac:chgData name="Sanfacon, Helene (AAFC/AAC)" userId="72064665-392b-46b2-86df-11307443f336" providerId="ADAL" clId="{DD047093-C355-48AC-A654-0BB6ED3A7D1C}" dt="2025-06-12T17:50:40.791" v="214" actId="208"/>
          <ac:spMkLst>
            <pc:docMk/>
            <pc:sldMk cId="2833429150" sldId="256"/>
            <ac:spMk id="4" creationId="{4AEB1BB4-18CD-854C-68E7-6871E2AF2EEA}"/>
          </ac:spMkLst>
        </pc:spChg>
        <pc:spChg chg="mod">
          <ac:chgData name="Sanfacon, Helene (AAFC/AAC)" userId="72064665-392b-46b2-86df-11307443f336" providerId="ADAL" clId="{DD047093-C355-48AC-A654-0BB6ED3A7D1C}" dt="2025-06-12T19:13:50.204" v="252" actId="20577"/>
          <ac:spMkLst>
            <pc:docMk/>
            <pc:sldMk cId="2833429150" sldId="256"/>
            <ac:spMk id="6" creationId="{9531691A-0960-FEE2-BD84-461A0BE0CA81}"/>
          </ac:spMkLst>
        </pc:spChg>
        <pc:picChg chg="mod">
          <ac:chgData name="Sanfacon, Helene (AAFC/AAC)" userId="72064665-392b-46b2-86df-11307443f336" providerId="ADAL" clId="{DD047093-C355-48AC-A654-0BB6ED3A7D1C}" dt="2025-06-12T17:50:52.139" v="216" actId="1076"/>
          <ac:picMkLst>
            <pc:docMk/>
            <pc:sldMk cId="2833429150" sldId="256"/>
            <ac:picMk id="5" creationId="{D8D19422-AA05-F358-2F05-EBF62D43D2B4}"/>
          </ac:picMkLst>
        </pc:picChg>
      </pc:sldChg>
      <pc:sldChg chg="del">
        <pc:chgData name="Sanfacon, Helene (AAFC/AAC)" userId="72064665-392b-46b2-86df-11307443f336" providerId="ADAL" clId="{DD047093-C355-48AC-A654-0BB6ED3A7D1C}" dt="2025-06-12T17:35:24.223" v="0" actId="47"/>
        <pc:sldMkLst>
          <pc:docMk/>
          <pc:sldMk cId="2460883530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D38F7B-10B7-AD50-F55B-BAD44ECC41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28C163-0F31-5B8E-5C86-0B09D65F4A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217985-7820-849E-A439-A79106BC2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4DB70D-4E55-0981-32B4-9EE0FCB23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29DEEE-74FF-44B9-5523-5BAC19FB1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2593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CA08F-C456-9D2F-5D5D-7C51C488FB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AB8043-432C-7EBA-6E2A-3142A41476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4227C-B998-CBF9-3D53-9CBC2D65C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D3822E-AD17-C7A3-30C7-FA0A6B889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D32907-01DF-6C6D-24B0-E58DFB8B3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64272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EA1621-1639-788D-1F51-D7B3ED8C4B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ADD275-40B4-6779-C2B1-76F5C6390A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3DF7C1-8CC5-6CE4-5863-A84301F15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AD71B-3C22-5083-0C60-73557092D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232125-2B3C-5373-265E-94757B677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68857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F3010-30FD-47D2-5C6B-FA5B8F9005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9B1519-C196-F81C-41D7-0D0F1F5822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0EA98E-0206-1FE5-2F52-27796FE5C6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C605E3-AAC7-DB23-615E-E3FFE5F3F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94470C-EA92-B84A-D729-812925CC9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46323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AAE022-57DB-AF28-2A39-B637D6F125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57669A-4519-937E-6285-209B7DEA07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305F87-1793-14F5-E0D2-D308E401A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F5BB5-B4D4-C819-B89E-181552CFB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9FAEE4-7B64-728E-D41C-95CBA051C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57354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B2C8FB-2926-EC06-3583-B11A784C7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C452B0-561B-8E2D-F25F-53C52D097F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16C5B9-ADCC-9A13-7369-66ADE2C853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FFD6CB-F07C-D732-A4AA-6E2F081F0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277159-CB37-0033-D04C-AC37DD9E3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9C7189-6FAB-B4AF-6145-E7FDE85DC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8358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E59C35-E052-AAA4-7EE1-683DBF1A7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2EE222-0077-2209-4492-0C40889404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5537D6-2388-DE7C-7CF8-FAE4A5CA85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FD6B2B-389D-F556-D2F9-DAAD02A155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23F082-D6E3-E15A-BB38-B57D3586E1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473121-BA17-DB4E-C5F7-45A1B78B4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1CC744-E13C-A7AA-0F42-75B0A1205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E352C0-05A5-06C5-EE14-CB4692BB2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2344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D949B9-0C2F-AF09-77A1-A4A02E2206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718ED9-76D4-13C7-9338-F2B1592F0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D56F72D-1899-DF17-1877-3174BCAA9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8B3033-B1C8-B150-62DD-D720952F6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59991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1C3637-9EDE-2B10-B48B-23BE86B49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DC83B6-37BB-8B3D-17FF-BA3734641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9FD3F6B-A9E9-1D01-02E5-08C58DFC3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37562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1E68D-56C5-5583-B389-62017652D7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E4EE35-B560-DFA7-1704-70515CBB28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1176AC-FFAE-4BEA-C2CD-AA1018DDB2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DA52F1-ECDD-44AD-DAF6-115214B5F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9D6004-384E-0712-ECB9-B2A4A2E40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9F6CBF-B988-135D-9524-EA03B5FF6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46417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69C00-724C-934A-AAF8-EE86C3FFED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FD8CD3-93AC-3A62-3ABF-D090CC4BA2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7F625E-326D-59CA-70C8-ACEB479589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5F6234-F46A-DDA7-A469-357F752FB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0EB885-8701-6A38-B93D-708D7D87B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39D5AB-FF82-98E6-DB80-A957AF561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01296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5BD1A6-BCA4-8E75-7B1E-0961D33AC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775C97-98CB-F700-5669-B58D6EC75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EBD3A4-C111-5DA9-E94F-9019BAC77B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8487B0-9579-4ACE-A3D0-487A71F4D2AD}" type="datetimeFigureOut">
              <a:rPr lang="en-CA" smtClean="0"/>
              <a:t>2025-06-12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5BF2EE-8532-60BC-4ECF-518C567E4C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7114C-DD74-5E3A-82CD-CCF54C5D25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D24984-0699-45C9-8F28-97E199C97C22}" type="slidenum">
              <a:rPr lang="en-CA" smtClean="0"/>
              <a:t>‹#›</a:t>
            </a:fld>
            <a:endParaRPr lang="en-CA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6F74CC5-AA80-6279-A395-B763BDDF84BA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5429250" y="63500"/>
            <a:ext cx="1393825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US" sz="1000">
                <a:solidFill>
                  <a:srgbClr val="000000">
                    <a:alpha val="50000"/>
                  </a:srgb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lassified / Non classifié</a:t>
            </a:r>
          </a:p>
        </p:txBody>
      </p:sp>
    </p:spTree>
    <p:extLst>
      <p:ext uri="{BB962C8B-B14F-4D97-AF65-F5344CB8AC3E}">
        <p14:creationId xmlns:p14="http://schemas.microsoft.com/office/powerpoint/2010/main" val="1506995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ue and red squares with white text&#10;&#10;AI-generated content may be incorrect.">
            <a:extLst>
              <a:ext uri="{FF2B5EF4-FFF2-40B4-BE49-F238E27FC236}">
                <a16:creationId xmlns:a16="http://schemas.microsoft.com/office/drawing/2014/main" id="{D8D19422-AA05-F358-2F05-EBF62D43D2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6" t="798" r="3020" b="3372"/>
          <a:stretch>
            <a:fillRect/>
          </a:stretch>
        </p:blipFill>
        <p:spPr>
          <a:xfrm>
            <a:off x="954314" y="1120066"/>
            <a:ext cx="4949371" cy="56556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531691A-0960-FEE2-BD84-461A0BE0CA81}"/>
              </a:ext>
            </a:extLst>
          </p:cNvPr>
          <p:cNvSpPr txBox="1"/>
          <p:nvPr/>
        </p:nvSpPr>
        <p:spPr>
          <a:xfrm>
            <a:off x="373743" y="7416801"/>
            <a:ext cx="574765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/>
              <a:t>S1 Fig. </a:t>
            </a:r>
            <a:r>
              <a:rPr lang="en-US" sz="1200" b="1" dirty="0"/>
              <a:t>Heat map illustrating the hierarchical clustering of samples based on their expression profiles</a:t>
            </a:r>
            <a:r>
              <a:rPr lang="en-US" sz="1200" dirty="0"/>
              <a:t>. To generate the heatmap, the following parameters were used: 1 - Pearson correlation (distance measure), average linkage (linkage criteria), fixed number of features: 1,000 (filter settings) and 10 (minimum counts in at least one sample).  </a:t>
            </a:r>
          </a:p>
          <a:p>
            <a:r>
              <a:rPr lang="en-US" sz="1200" dirty="0"/>
              <a:t> * indicates the region of the map that highlight DEGs common to symptomatic samples from all biological repeats</a:t>
            </a:r>
            <a:endParaRPr lang="en-CA" sz="1200" dirty="0"/>
          </a:p>
        </p:txBody>
      </p:sp>
      <p:sp>
        <p:nvSpPr>
          <p:cNvPr id="2" name="Right Brace 1">
            <a:extLst>
              <a:ext uri="{FF2B5EF4-FFF2-40B4-BE49-F238E27FC236}">
                <a16:creationId xmlns:a16="http://schemas.microsoft.com/office/drawing/2014/main" id="{613B8530-C2F5-8AF4-15A4-BCB37896AA41}"/>
              </a:ext>
            </a:extLst>
          </p:cNvPr>
          <p:cNvSpPr/>
          <p:nvPr/>
        </p:nvSpPr>
        <p:spPr>
          <a:xfrm>
            <a:off x="5918200" y="2960915"/>
            <a:ext cx="246743" cy="47897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B4D12C-FAB0-41F3-196B-CB0C6B26B8C3}"/>
              </a:ext>
            </a:extLst>
          </p:cNvPr>
          <p:cNvSpPr txBox="1"/>
          <p:nvPr/>
        </p:nvSpPr>
        <p:spPr>
          <a:xfrm>
            <a:off x="6121402" y="305604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*</a:t>
            </a: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AEB1BB4-18CD-854C-68E7-6871E2AF2EEA}"/>
              </a:ext>
            </a:extLst>
          </p:cNvPr>
          <p:cNvSpPr/>
          <p:nvPr/>
        </p:nvSpPr>
        <p:spPr>
          <a:xfrm>
            <a:off x="5050971" y="0"/>
            <a:ext cx="1807029" cy="47897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429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8</TotalTime>
  <Words>83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udel, Dinesh Babu</dc:creator>
  <cp:lastModifiedBy>Sanfacon, Helene (AAFC/AAC)</cp:lastModifiedBy>
  <cp:revision>1</cp:revision>
  <dcterms:created xsi:type="dcterms:W3CDTF">2025-06-12T03:08:27Z</dcterms:created>
  <dcterms:modified xsi:type="dcterms:W3CDTF">2025-06-12T19:13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aad8967-3ba6-4b00-a759-20a8ca19a393_Enabled">
    <vt:lpwstr>true</vt:lpwstr>
  </property>
  <property fmtid="{D5CDD505-2E9C-101B-9397-08002B2CF9AE}" pid="3" name="MSIP_Label_baad8967-3ba6-4b00-a759-20a8ca19a393_SetDate">
    <vt:lpwstr>2025-06-12T13:37:40Z</vt:lpwstr>
  </property>
  <property fmtid="{D5CDD505-2E9C-101B-9397-08002B2CF9AE}" pid="4" name="MSIP_Label_baad8967-3ba6-4b00-a759-20a8ca19a393_Method">
    <vt:lpwstr>Privileged</vt:lpwstr>
  </property>
  <property fmtid="{D5CDD505-2E9C-101B-9397-08002B2CF9AE}" pid="5" name="MSIP_Label_baad8967-3ba6-4b00-a759-20a8ca19a393_Name">
    <vt:lpwstr>UNCLASSIFIED</vt:lpwstr>
  </property>
  <property fmtid="{D5CDD505-2E9C-101B-9397-08002B2CF9AE}" pid="6" name="MSIP_Label_baad8967-3ba6-4b00-a759-20a8ca19a393_SiteId">
    <vt:lpwstr>9da98bb1-1857-4cc3-8751-9a49e35d24cd</vt:lpwstr>
  </property>
  <property fmtid="{D5CDD505-2E9C-101B-9397-08002B2CF9AE}" pid="7" name="MSIP_Label_baad8967-3ba6-4b00-a759-20a8ca19a393_ActionId">
    <vt:lpwstr>62b8e7f4-c13d-47e7-a734-9d3344ec070c</vt:lpwstr>
  </property>
  <property fmtid="{D5CDD505-2E9C-101B-9397-08002B2CF9AE}" pid="8" name="MSIP_Label_baad8967-3ba6-4b00-a759-20a8ca19a393_ContentBits">
    <vt:lpwstr>1</vt:lpwstr>
  </property>
  <property fmtid="{D5CDD505-2E9C-101B-9397-08002B2CF9AE}" pid="9" name="MSIP_Label_baad8967-3ba6-4b00-a759-20a8ca19a393_Tag">
    <vt:lpwstr>10, 0, 1, 1</vt:lpwstr>
  </property>
  <property fmtid="{D5CDD505-2E9C-101B-9397-08002B2CF9AE}" pid="10" name="ClassificationContentMarkingHeaderLocations">
    <vt:lpwstr>Office Theme:8</vt:lpwstr>
  </property>
  <property fmtid="{D5CDD505-2E9C-101B-9397-08002B2CF9AE}" pid="11" name="ClassificationContentMarkingHeaderText">
    <vt:lpwstr>Unclassified / Non classifié</vt:lpwstr>
  </property>
</Properties>
</file>